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11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1ECD3-6C8B-47CD-A20E-CEA4CB2538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512AC-9BC3-49E9-A984-038E87B1A5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1A1D75-3237-49F0-B506-C7ED3481B8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8EF4A-E49A-4E51-B3C8-4E76A1133C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9268B0-0BFC-4252-A1CD-2361A0FB56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2D8FD-0D80-48A2-9511-1F57FE1C26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37B20-3C3F-4D3B-9453-67CEDD0360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2A2851-0939-4B45-BCC1-00A5B8D523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5ABFC-8FA9-4362-9777-8F7F1FD7EB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7416B-12A2-4584-8667-DE5AAA80EC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AA4C0-058D-43A7-8E0A-E0C7E26AC1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8FC10-4B9D-44E5-ACFD-1699F80026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963485-A7B2-40E3-A0C9-534A2D4219B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86600" cy="57913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914400" y="304920"/>
            <a:ext cx="723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ultimedia Appendix 3: Screen shots of the final ADHD personal health applic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838080" y="838080"/>
            <a:ext cx="7620120" cy="4629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609480" y="1143000"/>
            <a:ext cx="7620120" cy="4667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838080" y="838080"/>
            <a:ext cx="6934320" cy="5486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1143000" y="1143000"/>
            <a:ext cx="7620120" cy="4686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1219320" y="762120"/>
            <a:ext cx="7619760" cy="4724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1143000" y="990720"/>
            <a:ext cx="7620120" cy="4714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838080" y="1219320"/>
            <a:ext cx="7620120" cy="469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609480" y="1143000"/>
            <a:ext cx="7620120" cy="4638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838080" y="914400"/>
            <a:ext cx="7620120" cy="4686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762120" y="914400"/>
            <a:ext cx="7619760" cy="4734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7T18:55:52Z</dcterms:created>
  <dc:creator>MG</dc:creator>
  <dc:description/>
  <dc:language>en-US</dc:language>
  <cp:lastModifiedBy>Colin Sox</cp:lastModifiedBy>
  <dcterms:modified xsi:type="dcterms:W3CDTF">2010-08-13T16:52:03Z</dcterms:modified>
  <cp:revision>9</cp:revision>
  <dc:subject/>
  <dc:title>IRB Screen Shots </dc:title>
</cp:coreProperties>
</file>